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480175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8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238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119505"/>
            <a:ext cx="5508149" cy="2381521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592866"/>
            <a:ext cx="4860131" cy="1651546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8004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0297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364195"/>
            <a:ext cx="1397288" cy="579704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364195"/>
            <a:ext cx="4110861" cy="579704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2061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4233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705386"/>
            <a:ext cx="5589151" cy="2845473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4577779"/>
            <a:ext cx="5589151" cy="149636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3801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820976"/>
            <a:ext cx="2754074" cy="43402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820976"/>
            <a:ext cx="2754074" cy="43402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934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64197"/>
            <a:ext cx="5589151" cy="13221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676882"/>
            <a:ext cx="2741417" cy="82181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498697"/>
            <a:ext cx="2741417" cy="36752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676882"/>
            <a:ext cx="2754918" cy="82181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498697"/>
            <a:ext cx="2754918" cy="36752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2996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9661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1281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56036"/>
            <a:ext cx="2090025" cy="1596126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984912"/>
            <a:ext cx="3280589" cy="4861216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052161"/>
            <a:ext cx="2090025" cy="3801883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7404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56036"/>
            <a:ext cx="2090025" cy="1596126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984912"/>
            <a:ext cx="3280589" cy="4861216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052161"/>
            <a:ext cx="2090025" cy="3801883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0540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364197"/>
            <a:ext cx="5589151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820976"/>
            <a:ext cx="5589151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6340167"/>
            <a:ext cx="1458039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CF4D30-218E-44D0-8B95-FD029FBA5D12}" type="datetimeFigureOut">
              <a:rPr lang="fr-FR" smtClean="0"/>
              <a:t>21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6340167"/>
            <a:ext cx="2187059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6340167"/>
            <a:ext cx="1458039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9EE377-F425-49D0-8A69-CC17F1B12E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5412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4">
            <a:extLst>
              <a:ext uri="{FF2B5EF4-FFF2-40B4-BE49-F238E27FC236}">
                <a16:creationId xmlns:a16="http://schemas.microsoft.com/office/drawing/2014/main" id="{2386DA92-A85F-489C-95B7-B47A60CBD6E5}"/>
              </a:ext>
            </a:extLst>
          </p:cNvPr>
          <p:cNvSpPr txBox="1">
            <a:spLocks/>
          </p:cNvSpPr>
          <p:nvPr/>
        </p:nvSpPr>
        <p:spPr>
          <a:xfrm>
            <a:off x="215389" y="685039"/>
            <a:ext cx="6093713" cy="116655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buNone/>
            </a:pPr>
            <a:r>
              <a:rPr lang="en-US" sz="1400" b="1" dirty="0">
                <a:solidFill>
                  <a:sysClr val="windowText" lastClr="000000"/>
                </a:solidFill>
              </a:rPr>
              <a:t>Supplemental_Fig_S7: Control photoreceptor progenitor cells RT-PCR results</a:t>
            </a:r>
          </a:p>
          <a:p>
            <a:pPr marL="0" indent="0" algn="just">
              <a:lnSpc>
                <a:spcPct val="100000"/>
              </a:lnSpc>
              <a:buNone/>
            </a:pPr>
            <a:r>
              <a:rPr lang="en-US" sz="1400" dirty="0"/>
              <a:t>RT-PCR was performed by using </a:t>
            </a:r>
            <a:r>
              <a:rPr lang="en-US" sz="1400" i="1" dirty="0"/>
              <a:t>ABCA4</a:t>
            </a:r>
            <a:r>
              <a:rPr lang="en-US" sz="1400" dirty="0"/>
              <a:t> </a:t>
            </a:r>
            <a:r>
              <a:rPr lang="en-US" sz="1400" dirty="0" err="1"/>
              <a:t>exonic</a:t>
            </a:r>
            <a:r>
              <a:rPr lang="en-US" sz="1400" dirty="0"/>
              <a:t> primers (exon 13-17). NES, natural exon skipping; CHX, cycloheximide (to suppress nonsense-mediated decay of mRNA).</a:t>
            </a:r>
            <a:endParaRPr lang="nl-NL" sz="1400" dirty="0"/>
          </a:p>
          <a:p>
            <a:pPr marL="0" indent="0" algn="just">
              <a:lnSpc>
                <a:spcPct val="100000"/>
              </a:lnSpc>
              <a:buNone/>
            </a:pPr>
            <a:endParaRPr lang="en-US" sz="1400" b="1" dirty="0">
              <a:solidFill>
                <a:sysClr val="windowText" lastClr="000000"/>
              </a:solidFill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37D7ED41-829C-4B24-8DAA-30C93407C5F9}"/>
              </a:ext>
            </a:extLst>
          </p:cNvPr>
          <p:cNvGrpSpPr/>
          <p:nvPr/>
        </p:nvGrpSpPr>
        <p:grpSpPr>
          <a:xfrm>
            <a:off x="2033792" y="2695056"/>
            <a:ext cx="3996452" cy="2204238"/>
            <a:chOff x="3049514" y="1990673"/>
            <a:chExt cx="3996452" cy="2204238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240466D-C105-4338-B772-2A6C3E092E27}"/>
                </a:ext>
              </a:extLst>
            </p:cNvPr>
            <p:cNvSpPr txBox="1"/>
            <p:nvPr/>
          </p:nvSpPr>
          <p:spPr>
            <a:xfrm rot="19073771">
              <a:off x="3536058" y="1990673"/>
              <a:ext cx="16372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/>
                <a:t>CHX_non</a:t>
              </a:r>
              <a:r>
                <a:rPr lang="en-US" sz="1400" b="1" dirty="0"/>
                <a:t>-treated</a:t>
              </a:r>
              <a:endParaRPr lang="nl-NL" sz="14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635D502-7B6D-4015-AB06-2D14CD76E34C}"/>
                </a:ext>
              </a:extLst>
            </p:cNvPr>
            <p:cNvSpPr txBox="1"/>
            <p:nvPr/>
          </p:nvSpPr>
          <p:spPr>
            <a:xfrm rot="19073771">
              <a:off x="4224294" y="2077432"/>
              <a:ext cx="14302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HX-treated</a:t>
              </a:r>
              <a:endParaRPr lang="nl-NL" sz="1400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B7DDE60-5ADE-417E-B64F-932EE0C3840B}"/>
                </a:ext>
              </a:extLst>
            </p:cNvPr>
            <p:cNvSpPr txBox="1"/>
            <p:nvPr/>
          </p:nvSpPr>
          <p:spPr>
            <a:xfrm>
              <a:off x="5018017" y="3337232"/>
              <a:ext cx="20279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xon 15 skipping (NES)</a:t>
              </a:r>
              <a:endParaRPr lang="nl-NL" sz="1400" dirty="0"/>
            </a:p>
          </p:txBody>
        </p:sp>
        <p:pic>
          <p:nvPicPr>
            <p:cNvPr id="9" name="Picture 2">
              <a:extLst>
                <a:ext uri="{FF2B5EF4-FFF2-40B4-BE49-F238E27FC236}">
                  <a16:creationId xmlns:a16="http://schemas.microsoft.com/office/drawing/2014/main" id="{DE45A784-32C1-4E0E-92AE-B62AECF1B59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28969" r="62703" b="57301"/>
            <a:stretch/>
          </p:blipFill>
          <p:spPr bwMode="auto">
            <a:xfrm>
              <a:off x="3593539" y="3887134"/>
              <a:ext cx="131507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1ECD9D4-0B79-426E-B031-5888D6CAD7D7}"/>
                </a:ext>
              </a:extLst>
            </p:cNvPr>
            <p:cNvSpPr txBox="1"/>
            <p:nvPr/>
          </p:nvSpPr>
          <p:spPr>
            <a:xfrm>
              <a:off x="3049514" y="3917912"/>
              <a:ext cx="6188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100" b="1" i="1" dirty="0"/>
                <a:t>ACTN</a:t>
              </a: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300A38BF-FE44-474D-B8F6-876E04CD3076}"/>
                </a:ext>
              </a:extLst>
            </p:cNvPr>
            <p:cNvGrpSpPr/>
            <p:nvPr/>
          </p:nvGrpSpPr>
          <p:grpSpPr>
            <a:xfrm>
              <a:off x="4968269" y="2917858"/>
              <a:ext cx="1276339" cy="307777"/>
              <a:chOff x="4899731" y="3000158"/>
              <a:chExt cx="1276339" cy="307777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BA45AAAA-6752-44D1-99AF-318FA0FEAF54}"/>
                  </a:ext>
                </a:extLst>
              </p:cNvPr>
              <p:cNvSpPr txBox="1"/>
              <p:nvPr/>
            </p:nvSpPr>
            <p:spPr>
              <a:xfrm>
                <a:off x="4955990" y="3000158"/>
                <a:ext cx="12200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PE insertions</a:t>
                </a:r>
                <a:endParaRPr lang="nl-NL" sz="1400" dirty="0"/>
              </a:p>
            </p:txBody>
          </p:sp>
          <p:sp>
            <p:nvSpPr>
              <p:cNvPr id="32" name="Right Brace 31">
                <a:extLst>
                  <a:ext uri="{FF2B5EF4-FFF2-40B4-BE49-F238E27FC236}">
                    <a16:creationId xmlns:a16="http://schemas.microsoft.com/office/drawing/2014/main" id="{E6DAAF39-4FBA-4F10-B73D-37028EFFC786}"/>
                  </a:ext>
                </a:extLst>
              </p:cNvPr>
              <p:cNvSpPr/>
              <p:nvPr/>
            </p:nvSpPr>
            <p:spPr>
              <a:xfrm>
                <a:off x="4899731" y="3035040"/>
                <a:ext cx="100649" cy="24622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0F52CD2-3B5A-44F9-8B0A-F05503651159}"/>
                </a:ext>
              </a:extLst>
            </p:cNvPr>
            <p:cNvSpPr txBox="1"/>
            <p:nvPr/>
          </p:nvSpPr>
          <p:spPr>
            <a:xfrm>
              <a:off x="5026895" y="3114106"/>
              <a:ext cx="14509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Normal fragment</a:t>
              </a:r>
              <a:endParaRPr lang="nl-NL" sz="1400" dirty="0"/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FE121D85-7692-40E8-BBB9-7721790BFBB2}"/>
                </a:ext>
              </a:extLst>
            </p:cNvPr>
            <p:cNvGrpSpPr/>
            <p:nvPr/>
          </p:nvGrpSpPr>
          <p:grpSpPr>
            <a:xfrm>
              <a:off x="3091463" y="2660159"/>
              <a:ext cx="1819916" cy="1183073"/>
              <a:chOff x="3044293" y="4499213"/>
              <a:chExt cx="1819916" cy="1183073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9CE804A7-C2A4-4DA8-B2D3-E5368D799A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1167"/>
              <a:stretch/>
            </p:blipFill>
            <p:spPr>
              <a:xfrm>
                <a:off x="3548430" y="4499213"/>
                <a:ext cx="1315779" cy="1181100"/>
              </a:xfrm>
              <a:prstGeom prst="rect">
                <a:avLst/>
              </a:prstGeom>
            </p:spPr>
          </p:pic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C2B1ABA2-566F-4BD8-AE66-E0776DF8054D}"/>
                  </a:ext>
                </a:extLst>
              </p:cNvPr>
              <p:cNvGrpSpPr/>
              <p:nvPr/>
            </p:nvGrpSpPr>
            <p:grpSpPr>
              <a:xfrm>
                <a:off x="3066434" y="5436065"/>
                <a:ext cx="471070" cy="246221"/>
                <a:chOff x="2161852" y="5456315"/>
                <a:chExt cx="471070" cy="246221"/>
              </a:xfrm>
            </p:grpSpPr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B5E7E31C-7191-4C37-B80E-1442AF32F7D7}"/>
                    </a:ext>
                  </a:extLst>
                </p:cNvPr>
                <p:cNvCxnSpPr/>
                <p:nvPr/>
              </p:nvCxnSpPr>
              <p:spPr>
                <a:xfrm>
                  <a:off x="2495762" y="5583766"/>
                  <a:ext cx="13716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D553715D-2610-4798-BAE8-CF15310A9A76}"/>
                    </a:ext>
                  </a:extLst>
                </p:cNvPr>
                <p:cNvSpPr txBox="1"/>
                <p:nvPr/>
              </p:nvSpPr>
              <p:spPr>
                <a:xfrm>
                  <a:off x="2161852" y="5456315"/>
                  <a:ext cx="40249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700</a:t>
                  </a:r>
                  <a:endParaRPr lang="nl-NL" sz="1000" b="1" dirty="0"/>
                </a:p>
              </p:txBody>
            </p:sp>
          </p:grp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1E43C0BD-AF05-4288-94A0-62B4287DDEF7}"/>
                  </a:ext>
                </a:extLst>
              </p:cNvPr>
              <p:cNvGrpSpPr/>
              <p:nvPr/>
            </p:nvGrpSpPr>
            <p:grpSpPr>
              <a:xfrm>
                <a:off x="3066434" y="5289513"/>
                <a:ext cx="471070" cy="246221"/>
                <a:chOff x="2161852" y="5456315"/>
                <a:chExt cx="471070" cy="246221"/>
              </a:xfrm>
            </p:grpSpPr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C21855C7-BB60-4CAF-B3B0-D26C2BA3F1CB}"/>
                    </a:ext>
                  </a:extLst>
                </p:cNvPr>
                <p:cNvCxnSpPr/>
                <p:nvPr/>
              </p:nvCxnSpPr>
              <p:spPr>
                <a:xfrm>
                  <a:off x="2495762" y="5583766"/>
                  <a:ext cx="13716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17030CB7-7413-4B6B-BCAE-FF44A9E6E6CE}"/>
                    </a:ext>
                  </a:extLst>
                </p:cNvPr>
                <p:cNvSpPr txBox="1"/>
                <p:nvPr/>
              </p:nvSpPr>
              <p:spPr>
                <a:xfrm>
                  <a:off x="2161852" y="5456315"/>
                  <a:ext cx="40249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800</a:t>
                  </a:r>
                  <a:endParaRPr lang="nl-NL" sz="1000" b="1" dirty="0"/>
                </a:p>
              </p:txBody>
            </p:sp>
          </p:grp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358F5DCE-E83C-43FD-9263-19073ABCEE02}"/>
                  </a:ext>
                </a:extLst>
              </p:cNvPr>
              <p:cNvGrpSpPr/>
              <p:nvPr/>
            </p:nvGrpSpPr>
            <p:grpSpPr>
              <a:xfrm>
                <a:off x="3077360" y="5147301"/>
                <a:ext cx="471070" cy="246221"/>
                <a:chOff x="2161852" y="5456315"/>
                <a:chExt cx="471070" cy="246221"/>
              </a:xfrm>
            </p:grpSpPr>
            <p:cxnSp>
              <p:nvCxnSpPr>
                <p:cNvPr id="25" name="Straight Connector 24">
                  <a:extLst>
                    <a:ext uri="{FF2B5EF4-FFF2-40B4-BE49-F238E27FC236}">
                      <a16:creationId xmlns:a16="http://schemas.microsoft.com/office/drawing/2014/main" id="{DD606F8C-99BF-41A7-92C4-35BA3343D0DA}"/>
                    </a:ext>
                  </a:extLst>
                </p:cNvPr>
                <p:cNvCxnSpPr/>
                <p:nvPr/>
              </p:nvCxnSpPr>
              <p:spPr>
                <a:xfrm>
                  <a:off x="2495762" y="5583766"/>
                  <a:ext cx="13716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EDD5E829-1D24-44B2-A73B-9236F8575E81}"/>
                    </a:ext>
                  </a:extLst>
                </p:cNvPr>
                <p:cNvSpPr txBox="1"/>
                <p:nvPr/>
              </p:nvSpPr>
              <p:spPr>
                <a:xfrm>
                  <a:off x="2161852" y="5456315"/>
                  <a:ext cx="40249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900</a:t>
                  </a:r>
                  <a:endParaRPr lang="nl-NL" sz="1000" b="1" dirty="0"/>
                </a:p>
              </p:txBody>
            </p:sp>
          </p:grp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80C139D9-6F7F-4431-ACE9-06C12A136B75}"/>
                  </a:ext>
                </a:extLst>
              </p:cNvPr>
              <p:cNvGrpSpPr/>
              <p:nvPr/>
            </p:nvGrpSpPr>
            <p:grpSpPr>
              <a:xfrm>
                <a:off x="3044293" y="5033601"/>
                <a:ext cx="498530" cy="246221"/>
                <a:chOff x="2134392" y="5456315"/>
                <a:chExt cx="498530" cy="246221"/>
              </a:xfrm>
            </p:grpSpPr>
            <p:cxnSp>
              <p:nvCxnSpPr>
                <p:cNvPr id="23" name="Straight Connector 22">
                  <a:extLst>
                    <a:ext uri="{FF2B5EF4-FFF2-40B4-BE49-F238E27FC236}">
                      <a16:creationId xmlns:a16="http://schemas.microsoft.com/office/drawing/2014/main" id="{C05CB4D5-A0A5-4659-8650-9CF90038EDE5}"/>
                    </a:ext>
                  </a:extLst>
                </p:cNvPr>
                <p:cNvCxnSpPr/>
                <p:nvPr/>
              </p:nvCxnSpPr>
              <p:spPr>
                <a:xfrm>
                  <a:off x="2495762" y="5583766"/>
                  <a:ext cx="13716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5D8B73CC-E095-469B-8B4F-1239A91D0D63}"/>
                    </a:ext>
                  </a:extLst>
                </p:cNvPr>
                <p:cNvSpPr txBox="1"/>
                <p:nvPr/>
              </p:nvSpPr>
              <p:spPr>
                <a:xfrm>
                  <a:off x="2134392" y="5456315"/>
                  <a:ext cx="46546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1000</a:t>
                  </a:r>
                  <a:endParaRPr lang="nl-NL" sz="1000" b="1" dirty="0"/>
                </a:p>
              </p:txBody>
            </p:sp>
          </p:grpSp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DCE2F871-DF49-401B-94C4-67CF88697B0D}"/>
                  </a:ext>
                </a:extLst>
              </p:cNvPr>
              <p:cNvGrpSpPr/>
              <p:nvPr/>
            </p:nvGrpSpPr>
            <p:grpSpPr>
              <a:xfrm>
                <a:off x="3045317" y="4857813"/>
                <a:ext cx="498530" cy="246221"/>
                <a:chOff x="2134392" y="5456315"/>
                <a:chExt cx="498530" cy="246221"/>
              </a:xfrm>
            </p:grpSpPr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164A0664-9C9A-4414-90D3-753075382556}"/>
                    </a:ext>
                  </a:extLst>
                </p:cNvPr>
                <p:cNvCxnSpPr/>
                <p:nvPr/>
              </p:nvCxnSpPr>
              <p:spPr>
                <a:xfrm>
                  <a:off x="2495762" y="5583766"/>
                  <a:ext cx="13716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6DF09BCA-2A84-4572-80A1-D44558414468}"/>
                    </a:ext>
                  </a:extLst>
                </p:cNvPr>
                <p:cNvSpPr txBox="1"/>
                <p:nvPr/>
              </p:nvSpPr>
              <p:spPr>
                <a:xfrm>
                  <a:off x="2134392" y="5456315"/>
                  <a:ext cx="46546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1200</a:t>
                  </a:r>
                  <a:endParaRPr lang="nl-NL" sz="1000" b="1" dirty="0"/>
                </a:p>
              </p:txBody>
            </p:sp>
          </p:grp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3AFB4CA-346A-4544-8688-58CA1D75377F}"/>
                  </a:ext>
                </a:extLst>
              </p:cNvPr>
              <p:cNvSpPr txBox="1"/>
              <p:nvPr/>
            </p:nvSpPr>
            <p:spPr>
              <a:xfrm>
                <a:off x="3118264" y="4636616"/>
                <a:ext cx="4697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bp</a:t>
                </a:r>
                <a:endParaRPr lang="nl-NL" sz="10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10018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2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enens, Claire-Marie</dc:creator>
  <cp:lastModifiedBy>Khan, Mubeen</cp:lastModifiedBy>
  <cp:revision>4</cp:revision>
  <dcterms:created xsi:type="dcterms:W3CDTF">2019-10-01T12:54:22Z</dcterms:created>
  <dcterms:modified xsi:type="dcterms:W3CDTF">2019-10-21T08:04:46Z</dcterms:modified>
</cp:coreProperties>
</file>